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E3B152-1FCC-4DD7-8652-976C0A268E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79E7B0-B744-42AD-BBC3-1E26539BD1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B9905D-8D97-4D54-84DD-FF6FCC4C725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9BB060-1489-4547-B2AA-285C7737ADF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4545B1-E9CC-4BEA-A235-0320336C5B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9BD63C-7586-4281-B351-2F33C3D97D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FB6DE6-351E-426D-AFE9-B676D21FB79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56AEE5-ED2D-4C78-8322-378B8D95E4B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87286E-A66F-4B20-96B1-9F772E05F85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2AAAD7-2E68-4B7E-8C3D-B96A97E3D87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3F27FA-B29C-4CB4-8F86-3A43905265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DF8324-0EF9-4056-8E63-F172D279E2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D394C4D-093B-45E3-9C5C-EDE07F3A2BD1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62"/>
          <p:cNvGrpSpPr/>
          <p:nvPr/>
        </p:nvGrpSpPr>
        <p:grpSpPr>
          <a:xfrm>
            <a:off x="1062000" y="1130400"/>
            <a:ext cx="6389280" cy="3853800"/>
            <a:chOff x="1062000" y="1130400"/>
            <a:chExt cx="6389280" cy="3853800"/>
          </a:xfrm>
        </p:grpSpPr>
        <p:sp>
          <p:nvSpPr>
            <p:cNvPr id="42" name="TextBox 1"/>
            <p:cNvSpPr/>
            <p:nvPr/>
          </p:nvSpPr>
          <p:spPr>
            <a:xfrm>
              <a:off x="3942000" y="1130400"/>
              <a:ext cx="1259640" cy="368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Total 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87 patients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TextBox 2"/>
            <p:cNvSpPr/>
            <p:nvPr/>
          </p:nvSpPr>
          <p:spPr>
            <a:xfrm>
              <a:off x="1062000" y="1830960"/>
              <a:ext cx="1259640" cy="64260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4 patients with missing KATEX result at treatment start excluded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44" name="Elbow Connector 4"/>
            <p:cNvCxnSpPr>
              <a:stCxn id="42" idx="2"/>
              <a:endCxn id="45" idx="0"/>
            </p:cNvCxnSpPr>
            <p:nvPr/>
          </p:nvCxnSpPr>
          <p:spPr>
            <a:xfrm rot="5400000">
              <a:off x="2161800" y="1657800"/>
              <a:ext cx="2568960" cy="2250720"/>
            </a:xfrm>
            <a:prstGeom prst="bentConnector3">
              <a:avLst>
                <a:gd name="adj1" fmla="val 49992"/>
              </a:avLst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cxnSp>
          <p:nvCxnSpPr>
            <p:cNvPr id="46" name="Straight Arrow Connector 7"/>
            <p:cNvCxnSpPr>
              <a:stCxn id="42" idx="2"/>
              <a:endCxn id="47" idx="0"/>
            </p:cNvCxnSpPr>
            <p:nvPr/>
          </p:nvCxnSpPr>
          <p:spPr>
            <a:xfrm flipH="1">
              <a:off x="4571280" y="1498680"/>
              <a:ext cx="720" cy="2556360"/>
            </a:xfrm>
            <a:prstGeom prst="straightConnector1">
              <a:avLst/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48" name="TextBox 39"/>
            <p:cNvSpPr/>
            <p:nvPr/>
          </p:nvSpPr>
          <p:spPr>
            <a:xfrm>
              <a:off x="3312000" y="1830960"/>
              <a:ext cx="1259640" cy="18770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 patients with missing aspirate result at treatment end excluded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(28 patients with less than three consecutive KATEX results during treatment excluded;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6 patients with short treatment duration excluded.)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9" name="Group 55"/>
            <p:cNvGrpSpPr/>
            <p:nvPr/>
          </p:nvGrpSpPr>
          <p:grpSpPr>
            <a:xfrm>
              <a:off x="1691640" y="4054680"/>
              <a:ext cx="5759640" cy="929520"/>
              <a:chOff x="1691640" y="4054680"/>
              <a:chExt cx="5759640" cy="929520"/>
            </a:xfrm>
          </p:grpSpPr>
          <p:sp>
            <p:nvSpPr>
              <p:cNvPr id="45" name="TextBox 10"/>
              <p:cNvSpPr/>
              <p:nvPr/>
            </p:nvSpPr>
            <p:spPr>
              <a:xfrm>
                <a:off x="1691640" y="4067280"/>
                <a:ext cx="1259640" cy="91692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9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Objective 1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9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73 patients 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included in diagnostic accuracy analysis for VL diagnosis, plus 97 controls.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" name="TextBox 23"/>
              <p:cNvSpPr/>
              <p:nvPr/>
            </p:nvSpPr>
            <p:spPr>
              <a:xfrm>
                <a:off x="3941640" y="4054680"/>
                <a:ext cx="1259640" cy="91692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9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Objective 2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9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74 (40) patients 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included in description of evolution during VL treatment.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TextBox 40"/>
              <p:cNvSpPr/>
              <p:nvPr/>
            </p:nvSpPr>
            <p:spPr>
              <a:xfrm>
                <a:off x="6191640" y="4054680"/>
                <a:ext cx="1259640" cy="77976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9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Objective 3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9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58 patients </a:t>
                </a: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  <a:ea typeface="Times New Roman"/>
                  </a:rPr>
                  <a:t>included in diagnostic accuracy analysis as test of cure.</a:t>
                </a:r>
                <a:endParaRPr b="0" lang="en-US" sz="9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cxnSp>
          <p:nvCxnSpPr>
            <p:cNvPr id="51" name="Elbow Connector 10"/>
            <p:cNvCxnSpPr>
              <a:stCxn id="42" idx="2"/>
              <a:endCxn id="50" idx="0"/>
            </p:cNvCxnSpPr>
            <p:nvPr/>
          </p:nvCxnSpPr>
          <p:spPr>
            <a:xfrm flipH="1" rot="16200000">
              <a:off x="4418280" y="1651680"/>
              <a:ext cx="2556360" cy="2250000"/>
            </a:xfrm>
            <a:prstGeom prst="bentConnector3">
              <a:avLst>
                <a:gd name="adj1" fmla="val 50000"/>
              </a:avLst>
            </a:prstGeom>
            <a:ln w="25560">
              <a:solidFill>
                <a:srgbClr val="000000"/>
              </a:solidFill>
              <a:miter/>
              <a:tailEnd len="med" type="arrow" w="med"/>
            </a:ln>
          </p:spPr>
        </p:cxnSp>
        <p:sp>
          <p:nvSpPr>
            <p:cNvPr id="52" name="TextBox 48"/>
            <p:cNvSpPr/>
            <p:nvPr/>
          </p:nvSpPr>
          <p:spPr>
            <a:xfrm>
              <a:off x="5562000" y="1837800"/>
              <a:ext cx="1259640" cy="11912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  <a:ea typeface="Arial"/>
                </a:rPr>
                <a:t>13 patients with missing aspirate result at treatment end excluded.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900" spc="-1" strike="noStrike">
                  <a:solidFill>
                    <a:srgbClr val="000000"/>
                  </a:solidFill>
                  <a:latin typeface="Arial"/>
                  <a:ea typeface="Times New Roman"/>
                </a:rPr>
                <a:t>16 patients with missing KATEX result at treatment end excluded</a:t>
              </a:r>
              <a:endParaRPr b="0" lang="en-US" sz="9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3" name="TextBox 1"/>
          <p:cNvSpPr/>
          <p:nvPr/>
        </p:nvSpPr>
        <p:spPr>
          <a:xfrm>
            <a:off x="1002240" y="5167440"/>
            <a:ext cx="4889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Material 1. Flowchart of patient inclusion for analyses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11-10T13:39:25Z</dcterms:created>
  <dc:creator>Florian Vogt</dc:creator>
  <dc:description/>
  <dc:language>en-US</dc:language>
  <cp:lastModifiedBy>Florian Vogt</cp:lastModifiedBy>
  <dcterms:modified xsi:type="dcterms:W3CDTF">2018-01-17T12:00:42Z</dcterms:modified>
  <cp:revision>5</cp:revision>
  <dc:subject/>
  <dc:title>PowerPoint Presentation</dc:title>
</cp:coreProperties>
</file>